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56" r:id="rId2"/>
    <p:sldId id="277" r:id="rId3"/>
    <p:sldId id="284" r:id="rId4"/>
    <p:sldId id="294" r:id="rId5"/>
    <p:sldId id="285" r:id="rId6"/>
    <p:sldId id="291" r:id="rId7"/>
    <p:sldId id="292" r:id="rId8"/>
    <p:sldId id="293" r:id="rId9"/>
    <p:sldId id="287" r:id="rId10"/>
    <p:sldId id="288" r:id="rId1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836" autoAdjust="0"/>
    <p:restoredTop sz="94660"/>
  </p:normalViewPr>
  <p:slideViewPr>
    <p:cSldViewPr snapToGrid="0">
      <p:cViewPr varScale="1">
        <p:scale>
          <a:sx n="79" d="100"/>
          <a:sy n="79" d="100"/>
        </p:scale>
        <p:origin x="99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84827D1-7AD3-4E88-A358-A6798AD58393}" type="datetimeFigureOut">
              <a:rPr lang="en-US" smtClean="0"/>
              <a:t>4/25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5C88DB4-2A6E-42B1-BCC3-4EBEDE2DEB5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18026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RI without contrast was performed following the admission to the emergency room to rule out a stroke. We present progressive slices from ventral to dorsal from fluid attenuated inversion recovery (FLAIR) (A) and diffusion weighted imaging (DWI) B1000 (B) sequences, as well as Time-of-Flight (</a:t>
            </a:r>
            <a:r>
              <a:rPr lang="en-US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oF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 angiography of intracranial vessels (C), without pathological findings.</a:t>
            </a:r>
            <a:endParaRPr lang="de-AT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de-AT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5C88DB4-2A6E-42B1-BCC3-4EBEDE2DEB54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136570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e patient was aphasic and presented with continuous lateralized rhythmic delta activity (LRDA) on the </a:t>
            </a:r>
            <a:r>
              <a:rPr lang="en-US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ronto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-</a:t>
            </a:r>
            <a:r>
              <a:rPr lang="en-US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entro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-temporal region (more prominent on Fp1-F3, F3-C3, Fp1-F7 and F7-T7; highlighted with red ovals) with a fluctuating frequency between 1.5 to 3 Hz. </a:t>
            </a:r>
            <a:endParaRPr lang="de-AT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de-AT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5C88DB4-2A6E-42B1-BCC3-4EBEDE2DEB54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291334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fter administration of 3000 mg of levetiracetam and 4 mg of lorazepam, there was no clinical improvement and only a slight decrease in rhythmicity shown on the EEG (highlighted with red ovals), which was compatible with a possible non-convulsive status epilepticus.</a:t>
            </a:r>
            <a:endParaRPr lang="de-AT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de-AT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5C88DB4-2A6E-42B1-BCC3-4EBEDE2DEB54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830729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uring a follow-up 3 weeks later, when the patient was asymptomatic, no relevant EEG changes were found.</a:t>
            </a:r>
            <a:endParaRPr lang="de-AT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de-AT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5C88DB4-2A6E-42B1-BCC3-4EBEDE2DEB54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08375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576C64-D33D-4875-B15B-228CEFBE96D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6C6523E-17EF-46C9-BF86-156230CDEEC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FB2AFA-C4D8-4765-B2E5-ABFBC2BED9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A1D74-C884-4593-AB7D-CC45B69C1709}" type="datetimeFigureOut">
              <a:rPr lang="en-US" smtClean="0"/>
              <a:t>4/2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AF08413-C71C-4AF7-BAF9-5870A3C150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46C0AB-215D-4BA6-BC08-1B600502AD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B9FE-3A98-436A-B65B-8155CB16A66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03646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9F5230-EC24-4DBB-9563-9DB5B65E02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B55CF2B-D7C1-4A31-BA7E-A3DCF81335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0B722E-F96C-423B-808C-29FA169902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A1D74-C884-4593-AB7D-CC45B69C1709}" type="datetimeFigureOut">
              <a:rPr lang="en-US" smtClean="0"/>
              <a:t>4/2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32C0F7-3EA5-4E97-939D-C7E0F905D6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AB3E83-3ED2-43CA-A9E7-614AF721EC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B9FE-3A98-436A-B65B-8155CB16A66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94361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6A2AEE2-BB6F-41BE-B671-91C5DFA3E93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7FEBC65-9CD2-4627-8E7A-2720A584B8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84B67C-BBDF-49C2-A091-1442A84675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A1D74-C884-4593-AB7D-CC45B69C1709}" type="datetimeFigureOut">
              <a:rPr lang="en-US" smtClean="0"/>
              <a:t>4/2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89511D-4CDC-4C6A-A2AF-F6633BA919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CE3787-2F9D-49B6-8BB7-A488CA8C2D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B9FE-3A98-436A-B65B-8155CB16A66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37766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2EC6C4-7FBE-42A2-B734-93DFEB0113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A638551-11BA-4EB5-9E96-6168DBA519E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93B23A-46A1-406E-A2AF-8A4B2BA496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A1D74-C884-4593-AB7D-CC45B69C1709}" type="datetimeFigureOut">
              <a:rPr lang="en-US" smtClean="0"/>
              <a:t>4/2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1499FE-6A6C-4582-9C56-97D9D74804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646AA1E-3717-41E1-A484-DE7085AAAD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B9FE-3A98-436A-B65B-8155CB16A66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13228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F64FC0-9A2E-46D4-B7E0-05F8946026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60DCBD9-9643-4C4E-9677-56E0C8A074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78B851-02C1-4090-A082-A685751DDF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A1D74-C884-4593-AB7D-CC45B69C1709}" type="datetimeFigureOut">
              <a:rPr lang="en-US" smtClean="0"/>
              <a:t>4/2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0047AC-A010-40BA-A187-6D6F505B8C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B46E82-7B89-4EF8-9D64-843A666668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B9FE-3A98-436A-B65B-8155CB16A66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74032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F6BF35-756B-484C-8B11-7BDD165DC3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A2D1C3C-7070-4932-8228-9808CD8B7F2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854B94D-0CB6-43DE-B2F8-8AD49E3C44A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978ABD7-BF13-4ED1-818C-7FF2961D30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A1D74-C884-4593-AB7D-CC45B69C1709}" type="datetimeFigureOut">
              <a:rPr lang="en-US" smtClean="0"/>
              <a:t>4/2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79E7F51-C22C-4329-88BE-06F827FB31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7EA249C-0FB6-424F-BD62-21CD5683ED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B9FE-3A98-436A-B65B-8155CB16A66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63918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99331E-5A70-4F63-A740-5226DEABA7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FB0BDA8-1BB0-4DD7-91AE-EADC457B35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547E6A5-AE1F-4978-B903-9F2708B6A15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0248BFB-77F4-4973-83A4-25DC1C0607D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B7CA3D4-1FBD-48BA-BAE3-17B63DD8B78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1C03382-9714-4F2C-9F18-1B40257A6C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A1D74-C884-4593-AB7D-CC45B69C1709}" type="datetimeFigureOut">
              <a:rPr lang="en-US" smtClean="0"/>
              <a:t>4/25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F34CB18-929B-4DCF-AEB6-21448397AB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8AA2E40-5D07-4E35-A00E-4939D799D9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B9FE-3A98-436A-B65B-8155CB16A66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18163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724C89-092F-4DFB-BD84-F157CAAAD4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C0EE58E-3234-4FB0-BE57-F823E96463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A1D74-C884-4593-AB7D-CC45B69C1709}" type="datetimeFigureOut">
              <a:rPr lang="en-US" smtClean="0"/>
              <a:t>4/25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D2CBD56-EC62-4987-B5CB-67362BCA00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AA09406-1DF3-4C2C-BB04-8EFB7E6F9A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B9FE-3A98-436A-B65B-8155CB16A66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49007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CAA88CA-3BD1-4805-B105-640662AA3F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A1D74-C884-4593-AB7D-CC45B69C1709}" type="datetimeFigureOut">
              <a:rPr lang="en-US" smtClean="0"/>
              <a:t>4/25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F8C8933-0304-4E72-9E11-C6C5977171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37D63E6-2250-450C-9E17-17D4B9B43E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B9FE-3A98-436A-B65B-8155CB16A66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4894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C01CF4-5A5D-49DA-B5AC-A0257B4845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A00F8D6-2EE6-47FF-A9EB-34C915C6E26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42D3E31-7E06-4995-91A7-14CBE420A6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3D75B8C-5211-40A7-B1C8-9BD953156B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A1D74-C884-4593-AB7D-CC45B69C1709}" type="datetimeFigureOut">
              <a:rPr lang="en-US" smtClean="0"/>
              <a:t>4/2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89E7157-FA15-4A4E-89FB-59CB881D1C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BB2987C-CD51-4CA5-8A0F-3147D5D2C7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B9FE-3A98-436A-B65B-8155CB16A66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45897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9951FC-5180-4D7F-825B-8B760A3BDF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448BB3D-F710-4624-A86F-7F0A7282E6D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6ACD5C8-FC42-4335-BE62-7E75A705906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4F82B0A-E6FC-4EC6-A042-CAB72B6914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A1D74-C884-4593-AB7D-CC45B69C1709}" type="datetimeFigureOut">
              <a:rPr lang="en-US" smtClean="0"/>
              <a:t>4/2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7432FA7-C471-4914-A421-C1504DB34B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F56C283-6E50-4BB8-9DF4-28F4F9A134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B9FE-3A98-436A-B65B-8155CB16A66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42989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83CECF1-CADE-48BD-864E-12E0DFF199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1AA4DEB-A1A0-4BA6-BBCF-7EE25F0CF3D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7CDF24-DD2C-46FE-B9F2-FDCFB9D539A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DA1D74-C884-4593-AB7D-CC45B69C1709}" type="datetimeFigureOut">
              <a:rPr lang="en-US" smtClean="0"/>
              <a:t>4/2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488C3C-44BC-4F19-86A6-78CC169A5B5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82FB53-8922-4D08-82D1-59D269B8A66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4FB9FE-3A98-436A-B65B-8155CB16A66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50032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7" Type="http://schemas.openxmlformats.org/officeDocument/2006/relationships/image" Target="../media/image5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jpg"/><Relationship Id="rId4" Type="http://schemas.openxmlformats.org/officeDocument/2006/relationships/image" Target="../media/image2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6.tif"/><Relationship Id="rId4" Type="http://schemas.openxmlformats.org/officeDocument/2006/relationships/image" Target="../media/image2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7.tif"/><Relationship Id="rId4" Type="http://schemas.openxmlformats.org/officeDocument/2006/relationships/image" Target="../media/image2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8.tif"/><Relationship Id="rId4" Type="http://schemas.openxmlformats.org/officeDocument/2006/relationships/image" Target="../media/image2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5A0C9F-0AC4-4612-87E6-6640752E60F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0" y="1687032"/>
            <a:ext cx="12192000" cy="1127494"/>
          </a:xfrm>
        </p:spPr>
        <p:txBody>
          <a:bodyPr>
            <a:normAutofit fontScale="90000"/>
          </a:bodyPr>
          <a:lstStyle/>
          <a:p>
            <a:r>
              <a:rPr lang="en-US" sz="40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rolonged Aura or Status Epilepticus? Unmasking a First-Time Migraine Attack</a:t>
            </a:r>
            <a:endParaRPr lang="en-US" sz="12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 descr="A picture containing text, clipart&#10;&#10;Description automatically generated">
            <a:extLst>
              <a:ext uri="{FF2B5EF4-FFF2-40B4-BE49-F238E27FC236}">
                <a16:creationId xmlns:a16="http://schemas.microsoft.com/office/drawing/2014/main" id="{18C5A51B-1E9E-2944-25C9-1C65590899F5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220" y="6156399"/>
            <a:ext cx="2342983" cy="594976"/>
          </a:xfrm>
          <a:prstGeom prst="rect">
            <a:avLst/>
          </a:prstGeom>
        </p:spPr>
      </p:pic>
      <p:pic>
        <p:nvPicPr>
          <p:cNvPr id="4" name="Picture 3" descr="A picture containing icon&#10;&#10;Description automatically generated">
            <a:extLst>
              <a:ext uri="{FF2B5EF4-FFF2-40B4-BE49-F238E27FC236}">
                <a16:creationId xmlns:a16="http://schemas.microsoft.com/office/drawing/2014/main" id="{FFE5E166-0B7C-0D56-6102-8620C6764D1E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91521" y="6156398"/>
            <a:ext cx="1168036" cy="594976"/>
          </a:xfrm>
          <a:prstGeom prst="rect">
            <a:avLst/>
          </a:prstGeom>
        </p:spPr>
      </p:pic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1337F9F9-8E94-4E18-CC41-8E5E553A559D}"/>
              </a:ext>
            </a:extLst>
          </p:cNvPr>
          <p:cNvCxnSpPr/>
          <p:nvPr/>
        </p:nvCxnSpPr>
        <p:spPr>
          <a:xfrm>
            <a:off x="88220" y="5980854"/>
            <a:ext cx="11907353" cy="0"/>
          </a:xfrm>
          <a:prstGeom prst="line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itle 1">
            <a:extLst>
              <a:ext uri="{FF2B5EF4-FFF2-40B4-BE49-F238E27FC236}">
                <a16:creationId xmlns:a16="http://schemas.microsoft.com/office/drawing/2014/main" id="{AF6877E5-15A1-EF06-6B68-5B78D5AB3E58}"/>
              </a:ext>
            </a:extLst>
          </p:cNvPr>
          <p:cNvSpPr txBox="1">
            <a:spLocks/>
          </p:cNvSpPr>
          <p:nvPr/>
        </p:nvSpPr>
        <p:spPr>
          <a:xfrm>
            <a:off x="0" y="3594811"/>
            <a:ext cx="12192000" cy="715107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iago Lerda Casaccia, MD; Michael </a:t>
            </a:r>
            <a:r>
              <a:rPr lang="en-US" sz="1800" i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Unterhofer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MD; Tobias Moser, MD, PhD; Markus Leitinger, MD, MSc; Giorgi </a:t>
            </a:r>
            <a:r>
              <a:rPr lang="en-US" sz="1800" i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Kuchukhidze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MD, PhD; Eugen Trinka, MD, MSc, FRCP; Pilar Bosque Varela, MD, 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hD</a:t>
            </a:r>
            <a:endParaRPr lang="de-AT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0651570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clipart&#10;&#10;Description automatically generated">
            <a:extLst>
              <a:ext uri="{FF2B5EF4-FFF2-40B4-BE49-F238E27FC236}">
                <a16:creationId xmlns:a16="http://schemas.microsoft.com/office/drawing/2014/main" id="{18C5A51B-1E9E-2944-25C9-1C65590899F5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220" y="6156399"/>
            <a:ext cx="2342983" cy="594976"/>
          </a:xfrm>
          <a:prstGeom prst="rect">
            <a:avLst/>
          </a:prstGeom>
        </p:spPr>
      </p:pic>
      <p:pic>
        <p:nvPicPr>
          <p:cNvPr id="4" name="Picture 3" descr="A picture containing icon&#10;&#10;Description automatically generated">
            <a:extLst>
              <a:ext uri="{FF2B5EF4-FFF2-40B4-BE49-F238E27FC236}">
                <a16:creationId xmlns:a16="http://schemas.microsoft.com/office/drawing/2014/main" id="{FFE5E166-0B7C-0D56-6102-8620C6764D1E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91521" y="6156398"/>
            <a:ext cx="1168036" cy="594976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B89BECC9-AB5A-80A0-06E4-7A14F65C2C04}"/>
              </a:ext>
            </a:extLst>
          </p:cNvPr>
          <p:cNvSpPr txBox="1"/>
          <p:nvPr/>
        </p:nvSpPr>
        <p:spPr>
          <a:xfrm>
            <a:off x="88220" y="0"/>
            <a:ext cx="6817659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4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clusion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D49817E1-9858-E40B-39FD-C6ACB2766262}"/>
              </a:ext>
            </a:extLst>
          </p:cNvPr>
          <p:cNvCxnSpPr/>
          <p:nvPr/>
        </p:nvCxnSpPr>
        <p:spPr>
          <a:xfrm>
            <a:off x="88220" y="5980854"/>
            <a:ext cx="11907353" cy="0"/>
          </a:xfrm>
          <a:prstGeom prst="line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Content Placeholder 2">
            <a:extLst>
              <a:ext uri="{FF2B5EF4-FFF2-40B4-BE49-F238E27FC236}">
                <a16:creationId xmlns:a16="http://schemas.microsoft.com/office/drawing/2014/main" id="{C118B30C-1AA3-2D80-0ACF-EF462D72F3C6}"/>
              </a:ext>
            </a:extLst>
          </p:cNvPr>
          <p:cNvSpPr txBox="1">
            <a:spLocks/>
          </p:cNvSpPr>
          <p:nvPr/>
        </p:nvSpPr>
        <p:spPr>
          <a:xfrm>
            <a:off x="88220" y="1099898"/>
            <a:ext cx="11471156" cy="4880956"/>
          </a:xfrm>
          <a:prstGeom prst="rect">
            <a:avLst/>
          </a:prstGeom>
        </p:spPr>
        <p:txBody>
          <a:bodyPr vert="horz" lIns="91440" tIns="45720" rIns="91440" bIns="45720" rtlCol="0">
            <a:normAutofit fontScale="70000" lnSpcReduction="20000"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457200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EEG abnormalities, such as </a:t>
            </a: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slow delta and theta waves</a:t>
            </a:r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, can be expected during migraine aura</a:t>
            </a:r>
          </a:p>
          <a:p>
            <a:pPr marL="457200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Clinical assessment plays a major role before applying the </a:t>
            </a: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Salzburg diagnostic criteria for NCSE</a:t>
            </a:r>
          </a:p>
          <a:p>
            <a:pPr marL="457200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Even though sensitivity and specificity of the criteria are high, the category of </a:t>
            </a: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possible NCSE</a:t>
            </a:r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 may also </a:t>
            </a: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encompass a broader range of patients with other conditions</a:t>
            </a:r>
          </a:p>
        </p:txBody>
      </p:sp>
    </p:spTree>
    <p:extLst>
      <p:ext uri="{BB962C8B-B14F-4D97-AF65-F5344CB8AC3E}">
        <p14:creationId xmlns:p14="http://schemas.microsoft.com/office/powerpoint/2010/main" val="33442019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clipart&#10;&#10;Description automatically generated">
            <a:extLst>
              <a:ext uri="{FF2B5EF4-FFF2-40B4-BE49-F238E27FC236}">
                <a16:creationId xmlns:a16="http://schemas.microsoft.com/office/drawing/2014/main" id="{18C5A51B-1E9E-2944-25C9-1C65590899F5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220" y="6156399"/>
            <a:ext cx="2342983" cy="594976"/>
          </a:xfrm>
          <a:prstGeom prst="rect">
            <a:avLst/>
          </a:prstGeom>
        </p:spPr>
      </p:pic>
      <p:pic>
        <p:nvPicPr>
          <p:cNvPr id="4" name="Picture 3" descr="A picture containing icon&#10;&#10;Description automatically generated">
            <a:extLst>
              <a:ext uri="{FF2B5EF4-FFF2-40B4-BE49-F238E27FC236}">
                <a16:creationId xmlns:a16="http://schemas.microsoft.com/office/drawing/2014/main" id="{FFE5E166-0B7C-0D56-6102-8620C6764D1E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91521" y="6156398"/>
            <a:ext cx="1168036" cy="594976"/>
          </a:xfrm>
          <a:prstGeom prst="rect">
            <a:avLst/>
          </a:prstGeom>
        </p:spPr>
      </p:pic>
      <p:sp>
        <p:nvSpPr>
          <p:cNvPr id="7" name="Content Placeholder 2">
            <a:extLst>
              <a:ext uri="{FF2B5EF4-FFF2-40B4-BE49-F238E27FC236}">
                <a16:creationId xmlns:a16="http://schemas.microsoft.com/office/drawing/2014/main" id="{3B5767DF-6FC1-C095-64AF-60097645628C}"/>
              </a:ext>
            </a:extLst>
          </p:cNvPr>
          <p:cNvSpPr txBox="1">
            <a:spLocks/>
          </p:cNvSpPr>
          <p:nvPr/>
        </p:nvSpPr>
        <p:spPr>
          <a:xfrm>
            <a:off x="88220" y="1055116"/>
            <a:ext cx="11471156" cy="48809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457200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One-third of patients with migraine have aura, which consist of 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focal neurological symptoms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that classically 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precede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the headache </a:t>
            </a:r>
          </a:p>
          <a:p>
            <a:pPr marL="457200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Certain 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typical presentations 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may mimic other neurological conditions, leading to diagnostic challenges</a:t>
            </a:r>
          </a:p>
          <a:p>
            <a:pPr marL="457200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We describe a patient who presented 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dden aphasia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and an 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ictal-interictal continuum (IIC; American Clinical Neurophysiology Society) on EEG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, mimicking a 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possible non-convulsive status epilepticus (NCSE) according to the Salzburg diagnostic criteria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89BECC9-AB5A-80A0-06E4-7A14F65C2C04}"/>
              </a:ext>
            </a:extLst>
          </p:cNvPr>
          <p:cNvSpPr txBox="1"/>
          <p:nvPr/>
        </p:nvSpPr>
        <p:spPr>
          <a:xfrm>
            <a:off x="88220" y="0"/>
            <a:ext cx="6817659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4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troduction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D49817E1-9858-E40B-39FD-C6ACB2766262}"/>
              </a:ext>
            </a:extLst>
          </p:cNvPr>
          <p:cNvCxnSpPr/>
          <p:nvPr/>
        </p:nvCxnSpPr>
        <p:spPr>
          <a:xfrm>
            <a:off x="88220" y="5980854"/>
            <a:ext cx="11907353" cy="0"/>
          </a:xfrm>
          <a:prstGeom prst="line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63584211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clipart&#10;&#10;Description automatically generated">
            <a:extLst>
              <a:ext uri="{FF2B5EF4-FFF2-40B4-BE49-F238E27FC236}">
                <a16:creationId xmlns:a16="http://schemas.microsoft.com/office/drawing/2014/main" id="{18C5A51B-1E9E-2944-25C9-1C65590899F5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220" y="6156399"/>
            <a:ext cx="2342983" cy="594976"/>
          </a:xfrm>
          <a:prstGeom prst="rect">
            <a:avLst/>
          </a:prstGeom>
        </p:spPr>
      </p:pic>
      <p:pic>
        <p:nvPicPr>
          <p:cNvPr id="4" name="Picture 3" descr="A picture containing icon&#10;&#10;Description automatically generated">
            <a:extLst>
              <a:ext uri="{FF2B5EF4-FFF2-40B4-BE49-F238E27FC236}">
                <a16:creationId xmlns:a16="http://schemas.microsoft.com/office/drawing/2014/main" id="{FFE5E166-0B7C-0D56-6102-8620C6764D1E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91521" y="6156398"/>
            <a:ext cx="1168036" cy="594976"/>
          </a:xfrm>
          <a:prstGeom prst="rect">
            <a:avLst/>
          </a:prstGeom>
        </p:spPr>
      </p:pic>
      <p:sp>
        <p:nvSpPr>
          <p:cNvPr id="7" name="Content Placeholder 2">
            <a:extLst>
              <a:ext uri="{FF2B5EF4-FFF2-40B4-BE49-F238E27FC236}">
                <a16:creationId xmlns:a16="http://schemas.microsoft.com/office/drawing/2014/main" id="{3B5767DF-6FC1-C095-64AF-60097645628C}"/>
              </a:ext>
            </a:extLst>
          </p:cNvPr>
          <p:cNvSpPr txBox="1">
            <a:spLocks/>
          </p:cNvSpPr>
          <p:nvPr/>
        </p:nvSpPr>
        <p:spPr>
          <a:xfrm>
            <a:off x="88220" y="877145"/>
            <a:ext cx="11471156" cy="48809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457200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25-year-old previously healthy man</a:t>
            </a:r>
          </a:p>
          <a:p>
            <a:pPr marL="457200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dden onset of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ensory aphasia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(fluent, incomprehensible speech, impaired comprehension, verbal and literal paraphasia and neologisms). Clinical examination revealed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no other deficits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457200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Laboratory work-ups (blood and urine, including toxicological tests) and an MRI with stroke protocol were normal</a:t>
            </a:r>
          </a:p>
          <a:p>
            <a:pPr marL="457200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200000"/>
              </a:lnSpc>
            </a:pP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89BECC9-AB5A-80A0-06E4-7A14F65C2C04}"/>
              </a:ext>
            </a:extLst>
          </p:cNvPr>
          <p:cNvSpPr txBox="1"/>
          <p:nvPr/>
        </p:nvSpPr>
        <p:spPr>
          <a:xfrm>
            <a:off x="88220" y="0"/>
            <a:ext cx="6817659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4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se Report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D49817E1-9858-E40B-39FD-C6ACB2766262}"/>
              </a:ext>
            </a:extLst>
          </p:cNvPr>
          <p:cNvCxnSpPr/>
          <p:nvPr/>
        </p:nvCxnSpPr>
        <p:spPr>
          <a:xfrm>
            <a:off x="88220" y="5980854"/>
            <a:ext cx="11907353" cy="0"/>
          </a:xfrm>
          <a:prstGeom prst="line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588066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6BE112F-7021-B327-6A5D-C251C62EF53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clipart&#10;&#10;Description automatically generated">
            <a:extLst>
              <a:ext uri="{FF2B5EF4-FFF2-40B4-BE49-F238E27FC236}">
                <a16:creationId xmlns:a16="http://schemas.microsoft.com/office/drawing/2014/main" id="{BC8D18A6-8A70-0373-05F9-E12819225860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220" y="6156399"/>
            <a:ext cx="2342983" cy="594976"/>
          </a:xfrm>
          <a:prstGeom prst="rect">
            <a:avLst/>
          </a:prstGeom>
        </p:spPr>
      </p:pic>
      <p:pic>
        <p:nvPicPr>
          <p:cNvPr id="4" name="Picture 3" descr="A picture containing icon&#10;&#10;Description automatically generated">
            <a:extLst>
              <a:ext uri="{FF2B5EF4-FFF2-40B4-BE49-F238E27FC236}">
                <a16:creationId xmlns:a16="http://schemas.microsoft.com/office/drawing/2014/main" id="{02D8FF4F-EDC0-FFBA-2371-3B41DCF77435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91521" y="6156398"/>
            <a:ext cx="1168036" cy="594976"/>
          </a:xfrm>
          <a:prstGeom prst="rect">
            <a:avLst/>
          </a:prstGeom>
        </p:spPr>
      </p:pic>
      <p:sp>
        <p:nvSpPr>
          <p:cNvPr id="7" name="Content Placeholder 2">
            <a:extLst>
              <a:ext uri="{FF2B5EF4-FFF2-40B4-BE49-F238E27FC236}">
                <a16:creationId xmlns:a16="http://schemas.microsoft.com/office/drawing/2014/main" id="{B9BF8A3A-3980-E486-0A61-109706C4F7F6}"/>
              </a:ext>
            </a:extLst>
          </p:cNvPr>
          <p:cNvSpPr txBox="1">
            <a:spLocks/>
          </p:cNvSpPr>
          <p:nvPr/>
        </p:nvSpPr>
        <p:spPr>
          <a:xfrm>
            <a:off x="88220" y="877145"/>
            <a:ext cx="11471156" cy="4880956"/>
          </a:xfrm>
          <a:prstGeom prst="rect">
            <a:avLst/>
          </a:prstGeom>
        </p:spPr>
        <p:txBody>
          <a:bodyPr vert="horz" lIns="91440" tIns="45720" rIns="91440" bIns="45720" rtlCol="0">
            <a:normAutofit fontScale="85000" lnSpcReduction="20000"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457200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EEG: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lateralized rhythmic delta activity (LRDA)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, 2.5-3 Hz with frequency fluctuation, no clear response to antiseizure medication (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IIC or possible NCSE according to the Salzburg criteri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marL="457200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fter aphasia resolved, the patient was able to report the symptoms that he had before developing aphasia: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evere headaches and a progressive spread of numbness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, spreading from the right hand to the arm and face </a:t>
            </a:r>
          </a:p>
          <a:p>
            <a:pPr marL="457200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He also reported having a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rst-degree relative with a diagnosis of migraine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457200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iagnosis was reconsidered to a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rst-time migraine attack with prolonged aur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. EEG which was done three weeks later, while the patient was asymptomatic, showed no abnormalities</a:t>
            </a:r>
          </a:p>
          <a:p>
            <a:pPr marL="457200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200000"/>
              </a:lnSpc>
            </a:pP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31476E0-589D-89A3-C89C-52491F3AF6C2}"/>
              </a:ext>
            </a:extLst>
          </p:cNvPr>
          <p:cNvSpPr txBox="1"/>
          <p:nvPr/>
        </p:nvSpPr>
        <p:spPr>
          <a:xfrm>
            <a:off x="88220" y="0"/>
            <a:ext cx="6817659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4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se Report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36B29BDE-BC8A-BDE4-D587-D2DE899B85EA}"/>
              </a:ext>
            </a:extLst>
          </p:cNvPr>
          <p:cNvCxnSpPr/>
          <p:nvPr/>
        </p:nvCxnSpPr>
        <p:spPr>
          <a:xfrm>
            <a:off x="88220" y="5980854"/>
            <a:ext cx="11907353" cy="0"/>
          </a:xfrm>
          <a:prstGeom prst="line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9864388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clipart&#10;&#10;Description automatically generated">
            <a:extLst>
              <a:ext uri="{FF2B5EF4-FFF2-40B4-BE49-F238E27FC236}">
                <a16:creationId xmlns:a16="http://schemas.microsoft.com/office/drawing/2014/main" id="{18C5A51B-1E9E-2944-25C9-1C65590899F5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220" y="6156399"/>
            <a:ext cx="2342983" cy="594976"/>
          </a:xfrm>
          <a:prstGeom prst="rect">
            <a:avLst/>
          </a:prstGeom>
        </p:spPr>
      </p:pic>
      <p:pic>
        <p:nvPicPr>
          <p:cNvPr id="4" name="Picture 3" descr="A picture containing icon&#10;&#10;Description automatically generated">
            <a:extLst>
              <a:ext uri="{FF2B5EF4-FFF2-40B4-BE49-F238E27FC236}">
                <a16:creationId xmlns:a16="http://schemas.microsoft.com/office/drawing/2014/main" id="{FFE5E166-0B7C-0D56-6102-8620C6764D1E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91521" y="6156398"/>
            <a:ext cx="1168036" cy="594976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B89BECC9-AB5A-80A0-06E4-7A14F65C2C04}"/>
              </a:ext>
            </a:extLst>
          </p:cNvPr>
          <p:cNvSpPr txBox="1"/>
          <p:nvPr/>
        </p:nvSpPr>
        <p:spPr>
          <a:xfrm>
            <a:off x="88220" y="0"/>
            <a:ext cx="6817659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4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1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D49817E1-9858-E40B-39FD-C6ACB2766262}"/>
              </a:ext>
            </a:extLst>
          </p:cNvPr>
          <p:cNvCxnSpPr/>
          <p:nvPr/>
        </p:nvCxnSpPr>
        <p:spPr>
          <a:xfrm>
            <a:off x="88220" y="5980854"/>
            <a:ext cx="11907353" cy="0"/>
          </a:xfrm>
          <a:prstGeom prst="line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Content Placeholder 2">
            <a:extLst>
              <a:ext uri="{FF2B5EF4-FFF2-40B4-BE49-F238E27FC236}">
                <a16:creationId xmlns:a16="http://schemas.microsoft.com/office/drawing/2014/main" id="{B1D66B96-333D-FCBA-FFA9-797A5DE58B94}"/>
              </a:ext>
            </a:extLst>
          </p:cNvPr>
          <p:cNvSpPr txBox="1">
            <a:spLocks/>
          </p:cNvSpPr>
          <p:nvPr/>
        </p:nvSpPr>
        <p:spPr>
          <a:xfrm>
            <a:off x="88220" y="5211418"/>
            <a:ext cx="6007780" cy="76943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>
              <a:lnSpc>
                <a:spcPct val="200000"/>
              </a:lnSpc>
            </a:pPr>
            <a:endParaRPr lang="en-US" sz="2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7085BD7C-A927-4BF1-3FD1-2B82A41E7A0D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241" b="31583"/>
          <a:stretch/>
        </p:blipFill>
        <p:spPr bwMode="auto">
          <a:xfrm>
            <a:off x="303396" y="909747"/>
            <a:ext cx="7328134" cy="2150534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1D680B8D-2A23-D434-1F19-25609D1B0892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93220" y="909747"/>
            <a:ext cx="2922905" cy="2694940"/>
          </a:xfrm>
          <a:prstGeom prst="rect">
            <a:avLst/>
          </a:prstGeom>
        </p:spPr>
      </p:pic>
      <p:sp>
        <p:nvSpPr>
          <p:cNvPr id="8" name="Textfeld 7">
            <a:extLst>
              <a:ext uri="{FF2B5EF4-FFF2-40B4-BE49-F238E27FC236}">
                <a16:creationId xmlns:a16="http://schemas.microsoft.com/office/drawing/2014/main" id="{C6AB9F1C-9DE2-205F-546B-985CB0C007C2}"/>
              </a:ext>
            </a:extLst>
          </p:cNvPr>
          <p:cNvSpPr txBox="1"/>
          <p:nvPr/>
        </p:nvSpPr>
        <p:spPr>
          <a:xfrm>
            <a:off x="7693220" y="3977234"/>
            <a:ext cx="4159649" cy="138499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just"/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RI without contrast was performed following the admission to the emergency room to rule out a stroke. We present progressive slices from ventral to dorsal from fluid attenuated inversion recovery (FLAIR) (A) and diffusion weighted imaging (DWI) B1000 (B) sequences, as well as Time-of-Flight (</a:t>
            </a:r>
            <a:r>
              <a:rPr lang="en-US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oF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 angiography of intracranial vessels (C), without pathological findings.</a:t>
            </a:r>
            <a:endParaRPr lang="de-AT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E76965D3-3AD0-F226-965F-F4E507EF6DB0}"/>
              </a:ext>
            </a:extLst>
          </p:cNvPr>
          <p:cNvSpPr txBox="1"/>
          <p:nvPr/>
        </p:nvSpPr>
        <p:spPr>
          <a:xfrm>
            <a:off x="223188" y="791602"/>
            <a:ext cx="41947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2800" dirty="0">
                <a:solidFill>
                  <a:schemeClr val="bg1"/>
                </a:solidFill>
              </a:rPr>
              <a:t>A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4B597F39-9C5E-39A4-F00B-54E6DE1C8E7A}"/>
              </a:ext>
            </a:extLst>
          </p:cNvPr>
          <p:cNvSpPr txBox="1"/>
          <p:nvPr/>
        </p:nvSpPr>
        <p:spPr>
          <a:xfrm>
            <a:off x="7631530" y="791602"/>
            <a:ext cx="41947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2800" dirty="0">
                <a:solidFill>
                  <a:schemeClr val="bg1"/>
                </a:solidFill>
              </a:rPr>
              <a:t>C</a:t>
            </a:r>
          </a:p>
        </p:txBody>
      </p:sp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119" b="27298"/>
          <a:stretch/>
        </p:blipFill>
        <p:spPr>
          <a:xfrm>
            <a:off x="303396" y="3044828"/>
            <a:ext cx="7328134" cy="2373610"/>
          </a:xfrm>
          <a:prstGeom prst="rect">
            <a:avLst/>
          </a:prstGeom>
        </p:spPr>
      </p:pic>
      <p:sp>
        <p:nvSpPr>
          <p:cNvPr id="19" name="Textfeld 18">
            <a:extLst>
              <a:ext uri="{FF2B5EF4-FFF2-40B4-BE49-F238E27FC236}">
                <a16:creationId xmlns:a16="http://schemas.microsoft.com/office/drawing/2014/main" id="{1A53EF30-BE9B-79EB-8D4C-BE54C6BAE214}"/>
              </a:ext>
            </a:extLst>
          </p:cNvPr>
          <p:cNvSpPr txBox="1"/>
          <p:nvPr/>
        </p:nvSpPr>
        <p:spPr>
          <a:xfrm>
            <a:off x="241706" y="2938977"/>
            <a:ext cx="41947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2800" dirty="0">
                <a:solidFill>
                  <a:schemeClr val="bg1"/>
                </a:solidFill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14630429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0C43C26-3CE2-668A-D313-334A3AD7116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clipart&#10;&#10;Description automatically generated">
            <a:extLst>
              <a:ext uri="{FF2B5EF4-FFF2-40B4-BE49-F238E27FC236}">
                <a16:creationId xmlns:a16="http://schemas.microsoft.com/office/drawing/2014/main" id="{61E83261-8383-1681-3D22-1C107D11018A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220" y="6156399"/>
            <a:ext cx="2342983" cy="594976"/>
          </a:xfrm>
          <a:prstGeom prst="rect">
            <a:avLst/>
          </a:prstGeom>
        </p:spPr>
      </p:pic>
      <p:pic>
        <p:nvPicPr>
          <p:cNvPr id="4" name="Picture 3" descr="A picture containing icon&#10;&#10;Description automatically generated">
            <a:extLst>
              <a:ext uri="{FF2B5EF4-FFF2-40B4-BE49-F238E27FC236}">
                <a16:creationId xmlns:a16="http://schemas.microsoft.com/office/drawing/2014/main" id="{3245ECED-5689-F1D8-B750-7C17AA7F7CBC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91521" y="6156398"/>
            <a:ext cx="1168036" cy="594976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5EF030A5-0E9D-2CFD-1BDE-AC25F6025883}"/>
              </a:ext>
            </a:extLst>
          </p:cNvPr>
          <p:cNvSpPr txBox="1"/>
          <p:nvPr/>
        </p:nvSpPr>
        <p:spPr>
          <a:xfrm>
            <a:off x="88220" y="0"/>
            <a:ext cx="6817659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4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2 - A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2C37D690-8CDA-F32A-9848-58DF3B486606}"/>
              </a:ext>
            </a:extLst>
          </p:cNvPr>
          <p:cNvCxnSpPr/>
          <p:nvPr/>
        </p:nvCxnSpPr>
        <p:spPr>
          <a:xfrm>
            <a:off x="88220" y="5980854"/>
            <a:ext cx="11907353" cy="0"/>
          </a:xfrm>
          <a:prstGeom prst="line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Content Placeholder 2">
            <a:extLst>
              <a:ext uri="{FF2B5EF4-FFF2-40B4-BE49-F238E27FC236}">
                <a16:creationId xmlns:a16="http://schemas.microsoft.com/office/drawing/2014/main" id="{5BEE28E7-AAFC-8D9D-AE4C-5BFC79A59879}"/>
              </a:ext>
            </a:extLst>
          </p:cNvPr>
          <p:cNvSpPr txBox="1">
            <a:spLocks/>
          </p:cNvSpPr>
          <p:nvPr/>
        </p:nvSpPr>
        <p:spPr>
          <a:xfrm>
            <a:off x="88220" y="5211418"/>
            <a:ext cx="6007780" cy="76943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>
              <a:lnSpc>
                <a:spcPct val="200000"/>
              </a:lnSpc>
            </a:pPr>
            <a:endParaRPr lang="en-US" sz="2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BF5BA368-9C49-A5BB-4890-44B604D8A4CD}"/>
              </a:ext>
            </a:extLst>
          </p:cNvPr>
          <p:cNvSpPr txBox="1"/>
          <p:nvPr/>
        </p:nvSpPr>
        <p:spPr>
          <a:xfrm>
            <a:off x="223188" y="791602"/>
            <a:ext cx="41947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2800" dirty="0">
                <a:solidFill>
                  <a:schemeClr val="bg1"/>
                </a:solidFill>
              </a:rPr>
              <a:t>A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1A97FA23-1EDC-AF9D-BD3A-4D113EEF89E5}"/>
              </a:ext>
            </a:extLst>
          </p:cNvPr>
          <p:cNvSpPr txBox="1"/>
          <p:nvPr/>
        </p:nvSpPr>
        <p:spPr>
          <a:xfrm>
            <a:off x="223188" y="3030341"/>
            <a:ext cx="41947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2800" dirty="0">
                <a:solidFill>
                  <a:schemeClr val="bg1"/>
                </a:solidFill>
              </a:rPr>
              <a:t>B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3172CC8D-8486-E285-2012-C19C1654153D}"/>
              </a:ext>
            </a:extLst>
          </p:cNvPr>
          <p:cNvSpPr txBox="1"/>
          <p:nvPr/>
        </p:nvSpPr>
        <p:spPr>
          <a:xfrm>
            <a:off x="7631530" y="791602"/>
            <a:ext cx="41947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2800" dirty="0">
                <a:solidFill>
                  <a:schemeClr val="bg1"/>
                </a:solidFill>
              </a:rPr>
              <a:t>C</a:t>
            </a:r>
          </a:p>
        </p:txBody>
      </p:sp>
      <p:pic>
        <p:nvPicPr>
          <p:cNvPr id="14" name="Grafik 13">
            <a:extLst>
              <a:ext uri="{FF2B5EF4-FFF2-40B4-BE49-F238E27FC236}">
                <a16:creationId xmlns:a16="http://schemas.microsoft.com/office/drawing/2014/main" id="{806447D4-BBEA-1DB3-5BB9-7C03C22D336F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582" t="9699" r="6911" b="18577"/>
          <a:stretch/>
        </p:blipFill>
        <p:spPr bwMode="auto">
          <a:xfrm>
            <a:off x="174093" y="845124"/>
            <a:ext cx="9890400" cy="4835993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16" name="Textfeld 15">
            <a:extLst>
              <a:ext uri="{FF2B5EF4-FFF2-40B4-BE49-F238E27FC236}">
                <a16:creationId xmlns:a16="http://schemas.microsoft.com/office/drawing/2014/main" id="{7DA5C03F-FF18-4CE9-850D-FD4F486C673B}"/>
              </a:ext>
            </a:extLst>
          </p:cNvPr>
          <p:cNvSpPr txBox="1"/>
          <p:nvPr/>
        </p:nvSpPr>
        <p:spPr>
          <a:xfrm>
            <a:off x="10125333" y="3401623"/>
            <a:ext cx="1978447" cy="230832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just"/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e patient was aphasic and presented with continuous lateralized rhythmic delta activity (LRDA) on the </a:t>
            </a:r>
            <a:r>
              <a:rPr lang="en-US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ronto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-</a:t>
            </a:r>
            <a:r>
              <a:rPr lang="en-US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entro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-temporal region (more prominent on Fp1-F3, F3-C3, Fp1-F7 and F7-T7; highlighted with red ovals) with a fluctuating frequency between 2.5 to 3 Hz. </a:t>
            </a:r>
            <a:endParaRPr lang="de-AT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6102164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35E959A-49D9-676B-784F-75AB5E21148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clipart&#10;&#10;Description automatically generated">
            <a:extLst>
              <a:ext uri="{FF2B5EF4-FFF2-40B4-BE49-F238E27FC236}">
                <a16:creationId xmlns:a16="http://schemas.microsoft.com/office/drawing/2014/main" id="{D92D101F-B467-DDA1-B7A5-9B4BE5D80B8B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220" y="6156399"/>
            <a:ext cx="2342983" cy="594976"/>
          </a:xfrm>
          <a:prstGeom prst="rect">
            <a:avLst/>
          </a:prstGeom>
        </p:spPr>
      </p:pic>
      <p:pic>
        <p:nvPicPr>
          <p:cNvPr id="4" name="Picture 3" descr="A picture containing icon&#10;&#10;Description automatically generated">
            <a:extLst>
              <a:ext uri="{FF2B5EF4-FFF2-40B4-BE49-F238E27FC236}">
                <a16:creationId xmlns:a16="http://schemas.microsoft.com/office/drawing/2014/main" id="{DB19CEAD-9B9E-967C-D641-5FB9496A5208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91521" y="6156398"/>
            <a:ext cx="1168036" cy="594976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B7F87AC3-6C79-AEBB-2A12-8BDBC8DE3B42}"/>
              </a:ext>
            </a:extLst>
          </p:cNvPr>
          <p:cNvSpPr txBox="1"/>
          <p:nvPr/>
        </p:nvSpPr>
        <p:spPr>
          <a:xfrm>
            <a:off x="88220" y="0"/>
            <a:ext cx="6817659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4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2 - B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A51D37AD-E321-FEA8-78AA-273442A76F70}"/>
              </a:ext>
            </a:extLst>
          </p:cNvPr>
          <p:cNvCxnSpPr/>
          <p:nvPr/>
        </p:nvCxnSpPr>
        <p:spPr>
          <a:xfrm>
            <a:off x="88220" y="5980854"/>
            <a:ext cx="11907353" cy="0"/>
          </a:xfrm>
          <a:prstGeom prst="line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Content Placeholder 2">
            <a:extLst>
              <a:ext uri="{FF2B5EF4-FFF2-40B4-BE49-F238E27FC236}">
                <a16:creationId xmlns:a16="http://schemas.microsoft.com/office/drawing/2014/main" id="{AC0B346E-BDFC-6BA2-E23C-944F6BD30917}"/>
              </a:ext>
            </a:extLst>
          </p:cNvPr>
          <p:cNvSpPr txBox="1">
            <a:spLocks/>
          </p:cNvSpPr>
          <p:nvPr/>
        </p:nvSpPr>
        <p:spPr>
          <a:xfrm>
            <a:off x="88220" y="5211418"/>
            <a:ext cx="6007780" cy="76943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>
              <a:lnSpc>
                <a:spcPct val="200000"/>
              </a:lnSpc>
            </a:pPr>
            <a:endParaRPr lang="en-US" sz="2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F4D3A4C5-A4B7-B8E0-619B-28D349B600D1}"/>
              </a:ext>
            </a:extLst>
          </p:cNvPr>
          <p:cNvSpPr txBox="1"/>
          <p:nvPr/>
        </p:nvSpPr>
        <p:spPr>
          <a:xfrm>
            <a:off x="223188" y="791602"/>
            <a:ext cx="41947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2800" dirty="0">
                <a:solidFill>
                  <a:schemeClr val="bg1"/>
                </a:solidFill>
              </a:rPr>
              <a:t>A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23BD16C3-599E-ED8F-9EAE-E168F0F172C4}"/>
              </a:ext>
            </a:extLst>
          </p:cNvPr>
          <p:cNvSpPr txBox="1"/>
          <p:nvPr/>
        </p:nvSpPr>
        <p:spPr>
          <a:xfrm>
            <a:off x="223188" y="3030341"/>
            <a:ext cx="41947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2800" dirty="0">
                <a:solidFill>
                  <a:schemeClr val="bg1"/>
                </a:solidFill>
              </a:rPr>
              <a:t>B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1F13D62D-EF10-C639-B31A-9B3EF121B010}"/>
              </a:ext>
            </a:extLst>
          </p:cNvPr>
          <p:cNvSpPr txBox="1"/>
          <p:nvPr/>
        </p:nvSpPr>
        <p:spPr>
          <a:xfrm>
            <a:off x="7631530" y="791602"/>
            <a:ext cx="41947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2800" dirty="0">
                <a:solidFill>
                  <a:schemeClr val="bg1"/>
                </a:solidFill>
              </a:rPr>
              <a:t>C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B3CAED71-B5EB-5918-DC4A-070D6EC71D5C}"/>
              </a:ext>
            </a:extLst>
          </p:cNvPr>
          <p:cNvSpPr txBox="1"/>
          <p:nvPr/>
        </p:nvSpPr>
        <p:spPr>
          <a:xfrm>
            <a:off x="10125333" y="3401623"/>
            <a:ext cx="1978447" cy="230832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just"/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fter administration of 3000 mg of levetiracetam and 4 mg of lorazepam, there was no clinical improvement and only a slight decrease in rhythmicity shown on the EEG (highlighted with red ovals), which was compatible with a possible non-convulsive status epilepticus.</a:t>
            </a:r>
            <a:endParaRPr lang="de-AT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DDC7590F-23FF-600E-62B3-71222D4BA151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734" t="9950" r="6495" b="17933"/>
          <a:stretch/>
        </p:blipFill>
        <p:spPr bwMode="auto">
          <a:xfrm>
            <a:off x="152225" y="877145"/>
            <a:ext cx="9889200" cy="4846513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  <p:extLst>
      <p:ext uri="{BB962C8B-B14F-4D97-AF65-F5344CB8AC3E}">
        <p14:creationId xmlns:p14="http://schemas.microsoft.com/office/powerpoint/2010/main" val="53726207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12C6256-DC79-F2B7-DBC0-1E6EFD9859A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clipart&#10;&#10;Description automatically generated">
            <a:extLst>
              <a:ext uri="{FF2B5EF4-FFF2-40B4-BE49-F238E27FC236}">
                <a16:creationId xmlns:a16="http://schemas.microsoft.com/office/drawing/2014/main" id="{E5850A10-DA29-54F7-A54A-855ED423F28A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220" y="6156399"/>
            <a:ext cx="2342983" cy="594976"/>
          </a:xfrm>
          <a:prstGeom prst="rect">
            <a:avLst/>
          </a:prstGeom>
        </p:spPr>
      </p:pic>
      <p:pic>
        <p:nvPicPr>
          <p:cNvPr id="4" name="Picture 3" descr="A picture containing icon&#10;&#10;Description automatically generated">
            <a:extLst>
              <a:ext uri="{FF2B5EF4-FFF2-40B4-BE49-F238E27FC236}">
                <a16:creationId xmlns:a16="http://schemas.microsoft.com/office/drawing/2014/main" id="{D07A5504-DBBC-12DE-C83C-CB740E5C2864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91521" y="6156398"/>
            <a:ext cx="1168036" cy="594976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A2700D31-FAFE-8A5E-6E0E-1166CAD5AE1B}"/>
              </a:ext>
            </a:extLst>
          </p:cNvPr>
          <p:cNvSpPr txBox="1"/>
          <p:nvPr/>
        </p:nvSpPr>
        <p:spPr>
          <a:xfrm>
            <a:off x="88220" y="0"/>
            <a:ext cx="6817659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4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2 - C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86B3F6CC-F3DB-2D29-A74D-ADC535B6ADD6}"/>
              </a:ext>
            </a:extLst>
          </p:cNvPr>
          <p:cNvCxnSpPr/>
          <p:nvPr/>
        </p:nvCxnSpPr>
        <p:spPr>
          <a:xfrm>
            <a:off x="88220" y="5980854"/>
            <a:ext cx="11907353" cy="0"/>
          </a:xfrm>
          <a:prstGeom prst="line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Content Placeholder 2">
            <a:extLst>
              <a:ext uri="{FF2B5EF4-FFF2-40B4-BE49-F238E27FC236}">
                <a16:creationId xmlns:a16="http://schemas.microsoft.com/office/drawing/2014/main" id="{54021426-044B-F6EC-A082-818D72507D35}"/>
              </a:ext>
            </a:extLst>
          </p:cNvPr>
          <p:cNvSpPr txBox="1">
            <a:spLocks/>
          </p:cNvSpPr>
          <p:nvPr/>
        </p:nvSpPr>
        <p:spPr>
          <a:xfrm>
            <a:off x="88220" y="5211418"/>
            <a:ext cx="6007780" cy="76943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>
              <a:lnSpc>
                <a:spcPct val="200000"/>
              </a:lnSpc>
            </a:pPr>
            <a:endParaRPr lang="en-US" sz="2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1088E0EB-CC8B-0A3F-8FBC-6854E3D6448C}"/>
              </a:ext>
            </a:extLst>
          </p:cNvPr>
          <p:cNvSpPr txBox="1"/>
          <p:nvPr/>
        </p:nvSpPr>
        <p:spPr>
          <a:xfrm>
            <a:off x="223188" y="791602"/>
            <a:ext cx="41947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2800" dirty="0">
                <a:solidFill>
                  <a:schemeClr val="bg1"/>
                </a:solidFill>
              </a:rPr>
              <a:t>A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099FCD6D-E4AC-6FD3-C51A-FA6112A7A67D}"/>
              </a:ext>
            </a:extLst>
          </p:cNvPr>
          <p:cNvSpPr txBox="1"/>
          <p:nvPr/>
        </p:nvSpPr>
        <p:spPr>
          <a:xfrm>
            <a:off x="223188" y="3030341"/>
            <a:ext cx="41947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2800" dirty="0">
                <a:solidFill>
                  <a:schemeClr val="bg1"/>
                </a:solidFill>
              </a:rPr>
              <a:t>B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282E7866-91C8-9993-734E-47823D2EA313}"/>
              </a:ext>
            </a:extLst>
          </p:cNvPr>
          <p:cNvSpPr txBox="1"/>
          <p:nvPr/>
        </p:nvSpPr>
        <p:spPr>
          <a:xfrm>
            <a:off x="7631530" y="791602"/>
            <a:ext cx="41947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2800" dirty="0">
                <a:solidFill>
                  <a:schemeClr val="bg1"/>
                </a:solidFill>
              </a:rPr>
              <a:t>C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D7D78BF7-F257-3802-CC35-07784E9E5C64}"/>
              </a:ext>
            </a:extLst>
          </p:cNvPr>
          <p:cNvSpPr txBox="1"/>
          <p:nvPr/>
        </p:nvSpPr>
        <p:spPr>
          <a:xfrm>
            <a:off x="10081110" y="4657128"/>
            <a:ext cx="1978447" cy="101566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just"/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uring a follow-up 3 weeks later, when the patient was asymptomatic, no relevant EEG changes were found.</a:t>
            </a:r>
            <a:endParaRPr lang="de-AT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Grafik 5">
            <a:extLst>
              <a:ext uri="{FF2B5EF4-FFF2-40B4-BE49-F238E27FC236}">
                <a16:creationId xmlns:a16="http://schemas.microsoft.com/office/drawing/2014/main" id="{C75E1F14-F3AD-B7BB-EAB4-C20B95D6676F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19" t="9798" r="8619" b="18676"/>
          <a:stretch/>
        </p:blipFill>
        <p:spPr bwMode="auto">
          <a:xfrm>
            <a:off x="165765" y="853449"/>
            <a:ext cx="9889200" cy="4819342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  <p:extLst>
      <p:ext uri="{BB962C8B-B14F-4D97-AF65-F5344CB8AC3E}">
        <p14:creationId xmlns:p14="http://schemas.microsoft.com/office/powerpoint/2010/main" val="198226886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clipart&#10;&#10;Description automatically generated">
            <a:extLst>
              <a:ext uri="{FF2B5EF4-FFF2-40B4-BE49-F238E27FC236}">
                <a16:creationId xmlns:a16="http://schemas.microsoft.com/office/drawing/2014/main" id="{18C5A51B-1E9E-2944-25C9-1C65590899F5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220" y="6156399"/>
            <a:ext cx="2342983" cy="594976"/>
          </a:xfrm>
          <a:prstGeom prst="rect">
            <a:avLst/>
          </a:prstGeom>
        </p:spPr>
      </p:pic>
      <p:pic>
        <p:nvPicPr>
          <p:cNvPr id="4" name="Picture 3" descr="A picture containing icon&#10;&#10;Description automatically generated">
            <a:extLst>
              <a:ext uri="{FF2B5EF4-FFF2-40B4-BE49-F238E27FC236}">
                <a16:creationId xmlns:a16="http://schemas.microsoft.com/office/drawing/2014/main" id="{FFE5E166-0B7C-0D56-6102-8620C6764D1E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91521" y="6156398"/>
            <a:ext cx="1168036" cy="594976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B89BECC9-AB5A-80A0-06E4-7A14F65C2C04}"/>
              </a:ext>
            </a:extLst>
          </p:cNvPr>
          <p:cNvSpPr txBox="1"/>
          <p:nvPr/>
        </p:nvSpPr>
        <p:spPr>
          <a:xfrm>
            <a:off x="88220" y="0"/>
            <a:ext cx="6817659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4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scussion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D49817E1-9858-E40B-39FD-C6ACB2766262}"/>
              </a:ext>
            </a:extLst>
          </p:cNvPr>
          <p:cNvCxnSpPr/>
          <p:nvPr/>
        </p:nvCxnSpPr>
        <p:spPr>
          <a:xfrm>
            <a:off x="88220" y="5980854"/>
            <a:ext cx="11907353" cy="0"/>
          </a:xfrm>
          <a:prstGeom prst="line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Content Placeholder 2">
            <a:extLst>
              <a:ext uri="{FF2B5EF4-FFF2-40B4-BE49-F238E27FC236}">
                <a16:creationId xmlns:a16="http://schemas.microsoft.com/office/drawing/2014/main" id="{C118B30C-1AA3-2D80-0ACF-EF462D72F3C6}"/>
              </a:ext>
            </a:extLst>
          </p:cNvPr>
          <p:cNvSpPr txBox="1">
            <a:spLocks/>
          </p:cNvSpPr>
          <p:nvPr/>
        </p:nvSpPr>
        <p:spPr>
          <a:xfrm>
            <a:off x="88220" y="877145"/>
            <a:ext cx="11471156" cy="4880956"/>
          </a:xfrm>
          <a:prstGeom prst="rect">
            <a:avLst/>
          </a:prstGeom>
        </p:spPr>
        <p:txBody>
          <a:bodyPr vert="horz" lIns="91440" tIns="45720" rIns="91440" bIns="45720" rtlCol="0">
            <a:normAutofit fontScale="70000" lnSpcReduction="20000"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457200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The patient’s initial presentation was </a:t>
            </a: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suggestive of NCSE</a:t>
            </a:r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, as characterized by sudden focal neurological symptoms, and EEG findings of fluctuating LRDA over the affected hemisphere</a:t>
            </a:r>
          </a:p>
          <a:p>
            <a:pPr marL="457200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EEG abnormalities have been described during migraine aura, in the form of </a:t>
            </a: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slowing over the affected hemisphere</a:t>
            </a:r>
          </a:p>
          <a:p>
            <a:pPr marL="457200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These findings may be </a:t>
            </a: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related to cortical spreading depression</a:t>
            </a:r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, the most widely accepted pathophysiological explanation of aura symptoms</a:t>
            </a:r>
          </a:p>
        </p:txBody>
      </p:sp>
    </p:spTree>
    <p:extLst>
      <p:ext uri="{BB962C8B-B14F-4D97-AF65-F5344CB8AC3E}">
        <p14:creationId xmlns:p14="http://schemas.microsoft.com/office/powerpoint/2010/main" val="21411193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07</Words>
  <Application>Microsoft Office PowerPoint</Application>
  <PresentationFormat>Panorámica</PresentationFormat>
  <Paragraphs>51</Paragraphs>
  <Slides>10</Slides>
  <Notes>4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0</vt:i4>
      </vt:variant>
    </vt:vector>
  </HeadingPairs>
  <TitlesOfParts>
    <vt:vector size="15" baseType="lpstr">
      <vt:lpstr>Arial</vt:lpstr>
      <vt:lpstr>Calibri</vt:lpstr>
      <vt:lpstr>Calibri Light</vt:lpstr>
      <vt:lpstr>Times New Roman</vt:lpstr>
      <vt:lpstr>Office Theme</vt:lpstr>
      <vt:lpstr>Prolonged Aura or Status Epilepticus? Unmasking a First-Time Migraine Attack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ominent ocular artifact from atypical ocular bobbing</dc:title>
  <dc:creator>Roohi Katyal</dc:creator>
  <cp:lastModifiedBy>pilar bosque varela</cp:lastModifiedBy>
  <cp:revision>64</cp:revision>
  <dcterms:created xsi:type="dcterms:W3CDTF">2021-09-03T02:53:53Z</dcterms:created>
  <dcterms:modified xsi:type="dcterms:W3CDTF">2025-04-25T15:51:46Z</dcterms:modified>
</cp:coreProperties>
</file>